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Rectangle 1"/>
          <p:cNvSpPr>
            <a:spLocks noChangeArrowheads="1"/>
          </p:cNvSpPr>
          <p:nvPr/>
        </p:nvSpPr>
        <p:spPr bwMode="auto">
          <a:xfrm>
            <a:off x="304800" y="228600"/>
            <a:ext cx="2743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S3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  <a:ea typeface="SimSun"/>
              </a:rPr>
              <a:t>Table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  <a:ea typeface="SimSun"/>
              </a:rPr>
              <a:t> Primers used in </a:t>
            </a:r>
            <a:r>
              <a:rPr lang="en-US" altLang="zh-CN" sz="12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qPCR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381000" y="716280"/>
          <a:ext cx="5791200" cy="3246122"/>
        </p:xfrm>
        <a:graphic>
          <a:graphicData uri="http://schemas.openxmlformats.org/drawingml/2006/table">
            <a:tbl>
              <a:tblPr/>
              <a:tblGrid>
                <a:gridCol w="2895600"/>
                <a:gridCol w="2895600"/>
              </a:tblGrid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Primer name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equence (5' → 3')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-F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GACGCTTGGCAAGATAGGA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-R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CTTTGGTGTCCCTCAATCG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-F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CTGCTGTGAACTGGATTGA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-R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CACCTAGAGAGCCTGCAAC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aSSy-F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CTACAAGGACGGCTCGAA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aSSy-R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TGTCGCAGAGCTTCATGTC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39v1-F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AGAGTCATTCTTGCCGGAGA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39v1-R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CCGAACTTTTCATCCATGT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EF1a-F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CCAGATCAATGAGCCCAAG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10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EF1a-R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AAGAGCTTCGTGGTGCATCT</a:t>
                      </a:r>
                    </a:p>
                  </a:txBody>
                  <a:tcPr marL="55756" marR="557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1766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Office PowerPoint</Application>
  <PresentationFormat>全屏显示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2</cp:revision>
  <dcterms:created xsi:type="dcterms:W3CDTF">2018-12-27T07:45:28Z</dcterms:created>
  <dcterms:modified xsi:type="dcterms:W3CDTF">2018-12-27T07:46:41Z</dcterms:modified>
</cp:coreProperties>
</file>